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6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D091-5963-4814-B792-8F940D9FD478}" type="datetimeFigureOut">
              <a:rPr lang="en-US" smtClean="0"/>
              <a:t>7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4DFD68-0589-4712-8F7A-B662EDE18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62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1044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250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47171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248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46142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0441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32848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296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3746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3895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7950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790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BDBE947-A01C-420D-AFF3-C8EBF961D366}"/>
              </a:ext>
            </a:extLst>
          </p:cNvPr>
          <p:cNvSpPr txBox="1"/>
          <p:nvPr/>
        </p:nvSpPr>
        <p:spPr>
          <a:xfrm>
            <a:off x="492832" y="432001"/>
            <a:ext cx="61470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/>
              <a:t>S2 FIGURE </a:t>
            </a:r>
            <a:r>
              <a:rPr lang="en-US" sz="1100" b="1" dirty="0"/>
              <a:t>2 | </a:t>
            </a:r>
            <a:r>
              <a:rPr lang="en-US" sz="1100" dirty="0"/>
              <a:t>Tryptic peptide coverage in light green of A) Nucleocapsid (NCAP_SARS2) and B) Membrane protein (VME1_SARS2). Data visualization in PD2.3. </a:t>
            </a:r>
            <a:endParaRPr lang="en-NL" sz="11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EE72C74-4AB1-45D1-A402-5FB175F6F80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7" t="8281" r="423" b="2088"/>
          <a:stretch/>
        </p:blipFill>
        <p:spPr>
          <a:xfrm>
            <a:off x="164177" y="1983461"/>
            <a:ext cx="6529645" cy="12660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612B1FB-AF12-4F9B-B0B1-D946EECA5C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1" t="10367" r="663"/>
          <a:stretch/>
        </p:blipFill>
        <p:spPr>
          <a:xfrm>
            <a:off x="164177" y="4471728"/>
            <a:ext cx="6475683" cy="11149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2111A70-0337-486C-81B3-9D89915FAF18}"/>
              </a:ext>
            </a:extLst>
          </p:cNvPr>
          <p:cNvSpPr txBox="1"/>
          <p:nvPr/>
        </p:nvSpPr>
        <p:spPr>
          <a:xfrm>
            <a:off x="485458" y="1601758"/>
            <a:ext cx="7400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)</a:t>
            </a:r>
            <a:endParaRPr lang="en-US" sz="11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CA04DEC-6A7B-4AD0-B36D-C13B85B61A3A}"/>
              </a:ext>
            </a:extLst>
          </p:cNvPr>
          <p:cNvSpPr txBox="1"/>
          <p:nvPr/>
        </p:nvSpPr>
        <p:spPr>
          <a:xfrm>
            <a:off x="444107" y="4046875"/>
            <a:ext cx="7400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)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015042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2</TotalTime>
  <Words>38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en Demmers</dc:creator>
  <cp:lastModifiedBy>J.A.A. Demmers</cp:lastModifiedBy>
  <cp:revision>445</cp:revision>
  <dcterms:created xsi:type="dcterms:W3CDTF">2020-04-19T12:14:45Z</dcterms:created>
  <dcterms:modified xsi:type="dcterms:W3CDTF">2021-07-15T09:35:39Z</dcterms:modified>
</cp:coreProperties>
</file>